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87" d="100"/>
          <a:sy n="87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742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201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114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612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031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550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661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594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245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305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017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3D0DEF-AD05-5C49-9CB6-85B980DAC1A7}" type="datetimeFigureOut">
              <a:rPr lang="en-US" smtClean="0"/>
              <a:t>6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F1B874B-B9C3-8847-8AA9-9668C45DD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848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D23350A-FCB7-549F-46E5-153787FE736A}"/>
              </a:ext>
            </a:extLst>
          </p:cNvPr>
          <p:cNvSpPr txBox="1"/>
          <p:nvPr/>
        </p:nvSpPr>
        <p:spPr>
          <a:xfrm>
            <a:off x="974445" y="2558450"/>
            <a:ext cx="5013399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ata availability</a:t>
            </a:r>
            <a:endParaRPr lang="en-US" altLang="en-US" sz="1200" dirty="0"/>
          </a:p>
          <a:p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he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cRNA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-seq data have been deposited in the GEO database under accession code GSE275858. Additional information and/or reagents are available from the authors on request. 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65B9D8D-1EEE-8643-7D32-DB23C6E72D6D}"/>
              </a:ext>
            </a:extLst>
          </p:cNvPr>
          <p:cNvSpPr txBox="1"/>
          <p:nvPr/>
        </p:nvSpPr>
        <p:spPr>
          <a:xfrm>
            <a:off x="530942" y="825908"/>
            <a:ext cx="514718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G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eatmap of gene expression in tumor cells of the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nd STAT3KO tumors formed +Dox and following Dox removal for 4 days. Distinct clusters of tumor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cells are noted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8561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65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ncy Reich Marshall</dc:creator>
  <cp:lastModifiedBy>Nancy Reich Marshall</cp:lastModifiedBy>
  <cp:revision>6</cp:revision>
  <dcterms:created xsi:type="dcterms:W3CDTF">2025-06-10T18:50:08Z</dcterms:created>
  <dcterms:modified xsi:type="dcterms:W3CDTF">2025-06-10T19:10:34Z</dcterms:modified>
</cp:coreProperties>
</file>